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1" r:id="rId6"/>
    <p:sldId id="258" r:id="rId7"/>
    <p:sldId id="257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66" y="-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887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7329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566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6346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1217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3606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0453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886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740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3556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919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455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1520" y="44624"/>
            <a:ext cx="86764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trient solution culture assay set-up used for empirical screening parental lines and DYDH lines for Mn</a:t>
            </a:r>
            <a:r>
              <a:rPr lang="en-AU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lerance,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s showing differential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n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xicity when grown in 125 µM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Cl</a:t>
            </a:r>
            <a:r>
              <a:rPr lang="en-AU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: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. </a:t>
            </a:r>
            <a:r>
              <a:rPr lang="en-A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ling showing extensive tangled root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stem.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: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ental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(1)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mor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2)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dal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3) Skipton; (4) Ag-Spectrum; (5)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pidor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6)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ngyou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7) Charlton; (8) Monty; (9</a:t>
            </a:r>
            <a:r>
              <a:rPr lang="en-AU" sz="120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AU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O94-67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(10)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u98-6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43608" y="10527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412776"/>
            <a:ext cx="7596335" cy="5064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9123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79512" y="274638"/>
            <a:ext cx="802432" cy="418058"/>
          </a:xfrm>
        </p:spPr>
        <p:txBody>
          <a:bodyPr>
            <a:noAutofit/>
          </a:bodyPr>
          <a:lstStyle/>
          <a:p>
            <a:pPr algn="l"/>
            <a:r>
              <a:rPr lang="en-AU" sz="2000" dirty="0" smtClean="0"/>
              <a:t>1B</a:t>
            </a:r>
            <a:endParaRPr lang="en-AU" sz="2000" dirty="0"/>
          </a:p>
        </p:txBody>
      </p:sp>
      <p:pic>
        <p:nvPicPr>
          <p:cNvPr id="5" name="Picture 2" descr="C:\Users\mcvittb\Pictures\Manganese Hydroponics\Run 1\11-4-17\IMG_698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853552"/>
            <a:ext cx="8831724" cy="58878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51520" y="1717648"/>
            <a:ext cx="828092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</a:rPr>
              <a:t>Scale     </a:t>
            </a:r>
          </a:p>
          <a:p>
            <a:r>
              <a:rPr lang="en-US" dirty="0">
                <a:solidFill>
                  <a:srgbClr val="FFFF00"/>
                </a:solidFill>
              </a:rPr>
              <a:t> </a:t>
            </a:r>
            <a:r>
              <a:rPr lang="en-US" dirty="0" smtClean="0">
                <a:solidFill>
                  <a:srgbClr val="FFFF00"/>
                </a:solidFill>
              </a:rPr>
              <a:t>     1                                    2                             3                               4                            5      </a:t>
            </a:r>
          </a:p>
          <a:p>
            <a:endParaRPr lang="en-US" dirty="0" smtClean="0">
              <a:solidFill>
                <a:srgbClr val="FFFF00"/>
              </a:solidFill>
            </a:endParaRPr>
          </a:p>
          <a:p>
            <a:endParaRPr lang="en-US" dirty="0">
              <a:solidFill>
                <a:srgbClr val="FFFF00"/>
              </a:solidFill>
            </a:endParaRPr>
          </a:p>
          <a:p>
            <a:endParaRPr lang="en-US" dirty="0" smtClean="0">
              <a:solidFill>
                <a:srgbClr val="FFFF00"/>
              </a:solidFill>
            </a:endParaRPr>
          </a:p>
          <a:p>
            <a:endParaRPr lang="en-US" dirty="0">
              <a:solidFill>
                <a:srgbClr val="FFFF00"/>
              </a:solidFill>
            </a:endParaRPr>
          </a:p>
          <a:p>
            <a:endParaRPr lang="en-US" dirty="0" smtClean="0">
              <a:solidFill>
                <a:srgbClr val="FFFF00"/>
              </a:solidFill>
            </a:endParaRPr>
          </a:p>
          <a:p>
            <a:endParaRPr lang="en-US" dirty="0">
              <a:solidFill>
                <a:srgbClr val="FFFF00"/>
              </a:solidFill>
            </a:endParaRPr>
          </a:p>
          <a:p>
            <a:endParaRPr lang="en-US" dirty="0" smtClean="0">
              <a:solidFill>
                <a:srgbClr val="FFFF00"/>
              </a:solidFill>
            </a:endParaRPr>
          </a:p>
          <a:p>
            <a:endParaRPr lang="en-US" dirty="0">
              <a:solidFill>
                <a:srgbClr val="FFFF00"/>
              </a:solidFill>
            </a:endParaRPr>
          </a:p>
          <a:p>
            <a:endParaRPr lang="en-US" dirty="0" smtClean="0">
              <a:solidFill>
                <a:srgbClr val="FFFF00"/>
              </a:solidFill>
            </a:endParaRPr>
          </a:p>
          <a:p>
            <a:endParaRPr lang="en-US" dirty="0" smtClean="0">
              <a:solidFill>
                <a:srgbClr val="FFFF00"/>
              </a:solidFill>
            </a:endParaRPr>
          </a:p>
          <a:p>
            <a:r>
              <a:rPr lang="en-US" smtClean="0">
                <a:solidFill>
                  <a:srgbClr val="FFFF00"/>
                </a:solidFill>
              </a:rPr>
              <a:t>chlorosis     </a:t>
            </a:r>
            <a:endParaRPr lang="en-US" dirty="0" smtClean="0">
              <a:solidFill>
                <a:srgbClr val="FFFF00"/>
              </a:solidFill>
            </a:endParaRPr>
          </a:p>
          <a:p>
            <a:r>
              <a:rPr lang="en-US" dirty="0" smtClean="0">
                <a:solidFill>
                  <a:srgbClr val="FFFF00"/>
                </a:solidFill>
              </a:rPr>
              <a:t>  </a:t>
            </a:r>
          </a:p>
          <a:p>
            <a:r>
              <a:rPr lang="en-US" dirty="0" smtClean="0">
                <a:solidFill>
                  <a:srgbClr val="FFFF00"/>
                </a:solidFill>
              </a:rPr>
              <a:t> 0-10 %                         10-25%	                      25-50%                    50-75%                 75-100%                     </a:t>
            </a:r>
            <a:endParaRPr lang="en-AU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0212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67544" y="332656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1C</a:t>
            </a:r>
            <a:endParaRPr lang="en-AU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268760"/>
            <a:ext cx="8183164" cy="3776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92577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55576" y="692696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mtClean="0"/>
              <a:t>1D</a:t>
            </a:r>
            <a:endParaRPr lang="en-AU" dirty="0"/>
          </a:p>
        </p:txBody>
      </p:sp>
      <p:grpSp>
        <p:nvGrpSpPr>
          <p:cNvPr id="4" name="Group 3"/>
          <p:cNvGrpSpPr/>
          <p:nvPr/>
        </p:nvGrpSpPr>
        <p:grpSpPr>
          <a:xfrm>
            <a:off x="1907704" y="548680"/>
            <a:ext cx="5832649" cy="6016758"/>
            <a:chOff x="1907704" y="548680"/>
            <a:chExt cx="5832649" cy="6016758"/>
          </a:xfrm>
        </p:grpSpPr>
        <p:pic>
          <p:nvPicPr>
            <p:cNvPr id="5" name="Picture 2" descr="C:\Users\mcvittb\Documents\Manganese\Parents\Tub 2 MnHR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7704" y="548680"/>
              <a:ext cx="5472607" cy="60167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1907704" y="98072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07704" y="213285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6</a:t>
              </a:r>
              <a:endParaRPr lang="en-AU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907704" y="3356992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8</a:t>
              </a:r>
              <a:endParaRPr lang="en-AU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07704" y="4581128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</a:t>
              </a:r>
              <a:endParaRPr lang="en-AU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907704" y="5733256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9</a:t>
              </a:r>
              <a:endParaRPr lang="en-AU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380311" y="980728"/>
              <a:ext cx="3600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7</a:t>
              </a:r>
              <a:endParaRPr lang="en-AU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308304" y="2132856"/>
              <a:ext cx="432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0</a:t>
              </a:r>
              <a:endParaRPr lang="en-AU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380312" y="3356992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5</a:t>
              </a:r>
              <a:endParaRPr lang="en-AU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380312" y="4581128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</a:t>
              </a:r>
              <a:endParaRPr lang="en-AU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380312" y="5805264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</a:t>
              </a:r>
              <a:endParaRPr lang="en-AU" dirty="0"/>
            </a:p>
          </p:txBody>
        </p:sp>
      </p:grpSp>
    </p:spTree>
    <p:extLst>
      <p:ext uri="{BB962C8B-B14F-4D97-AF65-F5344CB8AC3E}">
        <p14:creationId xmlns:p14="http://schemas.microsoft.com/office/powerpoint/2010/main" val="3452270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9BB73D8-C175-4385-8681-D121B1826FF2}">
  <ds:schemaRefs>
    <ds:schemaRef ds:uri="http://schemas.microsoft.com/office/2006/metadata/properties"/>
    <ds:schemaRef ds:uri="28de4f29-e3d9-478e-b05a-16a8ff0eb393"/>
  </ds:schemaRefs>
</ds:datastoreItem>
</file>

<file path=customXml/itemProps2.xml><?xml version="1.0" encoding="utf-8"?>
<ds:datastoreItem xmlns:ds="http://schemas.openxmlformats.org/officeDocument/2006/customXml" ds:itemID="{B23608D8-13BB-4BE2-9195-6BE4E3D7573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8de4f29-e3d9-478e-b05a-16a8ff0eb393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0D996FD3-A513-4029-8792-C796B0E4848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93</TotalTime>
  <Words>134</Words>
  <Application>Microsoft Office PowerPoint</Application>
  <PresentationFormat>On-screen Show (4:3)</PresentationFormat>
  <Paragraphs>3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1B</vt:lpstr>
      <vt:lpstr>PowerPoint Presentation</vt:lpstr>
      <vt:lpstr>PowerPoint Presentation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 Mcvittie</dc:creator>
  <cp:lastModifiedBy>NSW Government User</cp:lastModifiedBy>
  <cp:revision>31</cp:revision>
  <dcterms:created xsi:type="dcterms:W3CDTF">2017-08-15T00:38:58Z</dcterms:created>
  <dcterms:modified xsi:type="dcterms:W3CDTF">2017-11-20T03:47:49Z</dcterms:modified>
</cp:coreProperties>
</file>